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60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A648"/>
    <a:srgbClr val="381AEE"/>
    <a:srgbClr val="40E32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C6A472-7C24-41BA-ADBA-AB034C214A9D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B6BAA3-2E4C-47B4-BD39-4E2350389B0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282915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4DF88-D05F-4888-A2C8-0D2A414FDD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97E1C1-14C8-4306-8750-10A6CB83F0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ACBAE5-FD11-4AC1-90A2-3D5458218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09CBB9-D447-471C-A410-D7125D990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D3E935-5825-4C6C-B62C-B09BAA7BF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22246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8C961C-43BF-4E4E-A489-68BA47B87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F2824E-70A5-412C-9030-B695BF8156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22494-DACE-4B00-A975-5963D1EFC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1B6EF6-D59E-4E98-8089-E78303988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07A9E6-01F5-4959-903B-0E3FCA294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9778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DD1EC0-CCE2-4760-861F-DAF5F276E4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B03039-58C2-432F-B976-95E373AEF3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E789F-5431-465B-99F4-415CAA7A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D7ACE4-2D51-4F39-9377-89E94A06E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6809CE-0EA3-45F3-B090-7A1987B53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7899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FFEB0-2062-4E71-A417-79722E047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076291-B661-41FF-A352-2DE025B0E3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06FB7A-1389-4DEF-855B-50392EE5F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1970D-106C-482A-B5B2-4146FDAD5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EE6AF-89D4-402F-9D33-97048E537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8320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01BB65-794E-48EC-BEF1-6113360404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194911-E005-4749-A6EA-C137EFA13C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100B13-575C-417E-BDD9-9444F103F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1F255-88CB-40D5-9B39-E6E37AC87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AA7004-303B-4272-B71A-3D386199F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4305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999E36-D808-4386-9352-80EC0A106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B73ABB-92B4-489B-81B0-99D8D55DD6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5CF6A1-C923-46D3-9AB9-1DA0793E98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9B4600-D295-4668-9285-2D3EC4D28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AF9FE8-B073-4EA0-B49A-E8C7F8859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37A0F2-E2CE-40CA-832E-925D0866F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938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C4ABE8-CF49-4EC7-83BA-BE06661638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F625D0-C202-431B-8E1A-B37EF73FD8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D65866-93B9-41BA-8B1E-25DA95B4EC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3D6C05-3433-4BB1-A534-F4C18B39E6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AAF4F9-6EF5-4DAE-8C34-A1239B1731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5B89C2-5307-4CDC-95CB-0DCA1C537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018BD0-D89A-4EF4-9132-0BCE9A3B7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F60CCA-71B4-4225-9A46-2FD593781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6649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15E1F-2FD5-462C-8151-758A5F18B3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3F5D43-488A-4E27-AD65-F10D2FB7B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3CCD57-DEAE-46B5-A02F-AC33E050D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334798-8062-41A9-A7B7-202A4BE94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7447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ABD527-7A29-481E-90A1-3EB1E230A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7A59C3-2AC1-4388-B519-DF6EAA4A7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A09021-FA4C-4CF0-A896-823085CE2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6900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47CF6-EC33-440A-B9E4-190C50F4E5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785D69-083E-4174-B9EE-8357AA1AF5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6AEFF9-A41E-4C00-B86C-EBEBDC121C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968E96-E3E4-45DB-9DF0-CBF13F075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259EFD-486B-4DC0-8B50-99BAF9A20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82377-7BF0-480E-A406-6603E0EFF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8506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67F7E3-9F35-44A6-B3ED-59026B4FC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1B3C07-DC67-47DF-9EB7-075202CA09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1B5E34-D03F-414F-8037-CD39771DCF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F2C38F-618E-466C-A5D8-01FA3ECE3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B63D54-6B70-4E9F-9FD8-DB9A9EE23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5B4DF8-DB81-4C28-8280-3E329584B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000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D9D27E-57BB-4958-A19A-FBBA61588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729277-55F4-456E-8F65-75A5819AA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C35EE-9EE9-4401-A661-B0789D3CE2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6F8F1-3980-4A1E-A6DA-F9870954F0DA}" type="datetimeFigureOut">
              <a:rPr lang="en-IN" smtClean="0"/>
              <a:t>12-05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F3D83-4221-4AEB-A381-2EAAA1E34B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2E73BC-C95D-4954-AAFB-8A53B88354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730DAE-8916-413B-B4E0-D386B69F42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8701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/>
          <p:cNvGrpSpPr/>
          <p:nvPr/>
        </p:nvGrpSpPr>
        <p:grpSpPr>
          <a:xfrm>
            <a:off x="3371549" y="20053"/>
            <a:ext cx="5177354" cy="6172200"/>
            <a:chOff x="316069" y="0"/>
            <a:chExt cx="6212825" cy="8173452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C1A99EB-6F7C-412B-AE87-EEFFF416C6D6}"/>
                </a:ext>
              </a:extLst>
            </p:cNvPr>
            <p:cNvSpPr/>
            <p:nvPr/>
          </p:nvSpPr>
          <p:spPr>
            <a:xfrm flipH="1">
              <a:off x="618385" y="97060"/>
              <a:ext cx="1235879" cy="3938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sz="1333" b="1" dirty="0">
                  <a:latin typeface="Times New Roman" pitchFamily="18" charset="0"/>
                  <a:cs typeface="Times New Roman" pitchFamily="18" charset="0"/>
                </a:rPr>
                <a:t>Initial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3BBE3FE5-3498-44C3-BEFC-3581F4568A02}"/>
                </a:ext>
              </a:extLst>
            </p:cNvPr>
            <p:cNvSpPr/>
            <p:nvPr/>
          </p:nvSpPr>
          <p:spPr>
            <a:xfrm flipH="1">
              <a:off x="3618130" y="96252"/>
              <a:ext cx="1235879" cy="3938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sz="1333" b="1" dirty="0">
                  <a:latin typeface="Times New Roman" pitchFamily="18" charset="0"/>
                  <a:cs typeface="Times New Roman" pitchFamily="18" charset="0"/>
                </a:rPr>
                <a:t>Final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C96809FB-7DDA-4C7C-A7C2-6CF095CC9F71}"/>
                </a:ext>
              </a:extLst>
            </p:cNvPr>
            <p:cNvSpPr/>
            <p:nvPr/>
          </p:nvSpPr>
          <p:spPr>
            <a:xfrm flipH="1">
              <a:off x="388389" y="1083474"/>
              <a:ext cx="1235879" cy="326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IN" sz="1000" b="1" dirty="0">
                  <a:latin typeface="Times New Roman" pitchFamily="18" charset="0"/>
                  <a:cs typeface="Times New Roman" pitchFamily="18" charset="0"/>
                </a:rPr>
                <a:t>WT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DE4D1BC9-C063-4630-B94F-B3BC65B99BA0}"/>
                </a:ext>
              </a:extLst>
            </p:cNvPr>
            <p:cNvSpPr/>
            <p:nvPr/>
          </p:nvSpPr>
          <p:spPr>
            <a:xfrm flipH="1">
              <a:off x="316069" y="3842705"/>
              <a:ext cx="1235879" cy="326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IN" sz="1000" b="1" dirty="0">
                  <a:latin typeface="Times New Roman" pitchFamily="18" charset="0"/>
                  <a:cs typeface="Times New Roman" pitchFamily="18" charset="0"/>
                </a:rPr>
                <a:t>D157Y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1A94DE0B-6C23-4C87-91D8-828DBD8EBC92}"/>
                </a:ext>
              </a:extLst>
            </p:cNvPr>
            <p:cNvSpPr/>
            <p:nvPr/>
          </p:nvSpPr>
          <p:spPr>
            <a:xfrm flipH="1">
              <a:off x="367633" y="6369157"/>
              <a:ext cx="1235879" cy="326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IN" sz="1000" b="1" dirty="0">
                  <a:latin typeface="Times New Roman" pitchFamily="18" charset="0"/>
                  <a:cs typeface="Times New Roman" pitchFamily="18" charset="0"/>
                </a:rPr>
                <a:t>R135T</a:t>
              </a:r>
            </a:p>
          </p:txBody>
        </p:sp>
        <p:pic>
          <p:nvPicPr>
            <p:cNvPr id="37" name="Picture 36" descr="A close up of a map&#10;&#10;Description generated with very high confidence">
              <a:extLst>
                <a:ext uri="{FF2B5EF4-FFF2-40B4-BE49-F238E27FC236}">
                  <a16:creationId xmlns:a16="http://schemas.microsoft.com/office/drawing/2014/main" id="{A6907A7E-6E80-4A6E-9CA4-AEC4A9C1FE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85" t="5883" r="28889" b="4621"/>
            <a:stretch/>
          </p:blipFill>
          <p:spPr>
            <a:xfrm>
              <a:off x="1423152" y="141889"/>
              <a:ext cx="1680026" cy="2459419"/>
            </a:xfrm>
            <a:prstGeom prst="rect">
              <a:avLst/>
            </a:prstGeom>
          </p:spPr>
        </p:pic>
        <p:pic>
          <p:nvPicPr>
            <p:cNvPr id="38" name="Picture 37" descr="A close up of a logo&#10;&#10;Description generated with high confidence">
              <a:extLst>
                <a:ext uri="{FF2B5EF4-FFF2-40B4-BE49-F238E27FC236}">
                  <a16:creationId xmlns:a16="http://schemas.microsoft.com/office/drawing/2014/main" id="{370B262F-D9A7-41EE-BB75-3597CA38E3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33" t="15454" r="28333" b="10608"/>
            <a:stretch/>
          </p:blipFill>
          <p:spPr>
            <a:xfrm>
              <a:off x="4209356" y="0"/>
              <a:ext cx="1990837" cy="2541533"/>
            </a:xfrm>
            <a:prstGeom prst="rect">
              <a:avLst/>
            </a:prstGeom>
          </p:spPr>
        </p:pic>
        <p:pic>
          <p:nvPicPr>
            <p:cNvPr id="39" name="Picture 38" descr="A close up of a flower&#10;&#10;Description generated with high confidence">
              <a:extLst>
                <a:ext uri="{FF2B5EF4-FFF2-40B4-BE49-F238E27FC236}">
                  <a16:creationId xmlns:a16="http://schemas.microsoft.com/office/drawing/2014/main" id="{364CD418-5102-4A1E-A7FE-934811E534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47" t="2218" r="30042"/>
            <a:stretch/>
          </p:blipFill>
          <p:spPr>
            <a:xfrm>
              <a:off x="1275592" y="2894706"/>
              <a:ext cx="1797975" cy="2675777"/>
            </a:xfrm>
            <a:prstGeom prst="rect">
              <a:avLst/>
            </a:prstGeom>
          </p:spPr>
        </p:pic>
        <p:pic>
          <p:nvPicPr>
            <p:cNvPr id="40" name="Picture 39" descr="A necklace with a piece of paper&#10;&#10;Description generated with high confidence">
              <a:extLst>
                <a:ext uri="{FF2B5EF4-FFF2-40B4-BE49-F238E27FC236}">
                  <a16:creationId xmlns:a16="http://schemas.microsoft.com/office/drawing/2014/main" id="{A4BCDC81-FB4E-4B33-A771-720E2B80EA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39" t="7467" r="32105" b="6975"/>
            <a:stretch/>
          </p:blipFill>
          <p:spPr>
            <a:xfrm>
              <a:off x="4393398" y="2852352"/>
              <a:ext cx="1843705" cy="2607115"/>
            </a:xfrm>
            <a:prstGeom prst="rect">
              <a:avLst/>
            </a:prstGeom>
          </p:spPr>
        </p:pic>
        <p:pic>
          <p:nvPicPr>
            <p:cNvPr id="41" name="Picture 40" descr="A close up of a map&#10;&#10;Description generated with very high confidence">
              <a:extLst>
                <a:ext uri="{FF2B5EF4-FFF2-40B4-BE49-F238E27FC236}">
                  <a16:creationId xmlns:a16="http://schemas.microsoft.com/office/drawing/2014/main" id="{FEA2D6FA-2447-4710-AC4A-1BE58471BF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31" t="3633" r="30792" b="5759"/>
            <a:stretch/>
          </p:blipFill>
          <p:spPr>
            <a:xfrm>
              <a:off x="1464666" y="5553695"/>
              <a:ext cx="1735734" cy="2619757"/>
            </a:xfrm>
            <a:prstGeom prst="rect">
              <a:avLst/>
            </a:prstGeom>
          </p:spPr>
        </p:pic>
        <p:pic>
          <p:nvPicPr>
            <p:cNvPr id="42" name="Picture 41" descr="A close up of a necklace&#10;&#10;Description generated with high confidence">
              <a:extLst>
                <a:ext uri="{FF2B5EF4-FFF2-40B4-BE49-F238E27FC236}">
                  <a16:creationId xmlns:a16="http://schemas.microsoft.com/office/drawing/2014/main" id="{105F2424-4BA9-46FA-8483-0E74ECE64D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78" t="14255" r="30556" b="13603"/>
            <a:stretch/>
          </p:blipFill>
          <p:spPr>
            <a:xfrm>
              <a:off x="4629150" y="5777132"/>
              <a:ext cx="1899744" cy="2357218"/>
            </a:xfrm>
            <a:prstGeom prst="rect">
              <a:avLst/>
            </a:prstGeom>
          </p:spPr>
        </p:pic>
      </p:grpSp>
      <p:sp>
        <p:nvSpPr>
          <p:cNvPr id="44" name="TextBox 43"/>
          <p:cNvSpPr txBox="1"/>
          <p:nvPr/>
        </p:nvSpPr>
        <p:spPr>
          <a:xfrm>
            <a:off x="2448596" y="6382319"/>
            <a:ext cx="8379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ure S1: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Initial model and final model systems of WT, R135T and D157Y during simulation run.</a:t>
            </a:r>
          </a:p>
        </p:txBody>
      </p:sp>
    </p:spTree>
    <p:extLst>
      <p:ext uri="{BB962C8B-B14F-4D97-AF65-F5344CB8AC3E}">
        <p14:creationId xmlns:p14="http://schemas.microsoft.com/office/powerpoint/2010/main" val="14560743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>
            <a:extLst>
              <a:ext uri="{FF2B5EF4-FFF2-40B4-BE49-F238E27FC236}">
                <a16:creationId xmlns:a16="http://schemas.microsoft.com/office/drawing/2014/main" id="{26204399-71E0-47F0-832D-5FF05D157DCE}"/>
              </a:ext>
            </a:extLst>
          </p:cNvPr>
          <p:cNvGrpSpPr/>
          <p:nvPr/>
        </p:nvGrpSpPr>
        <p:grpSpPr>
          <a:xfrm>
            <a:off x="1565784" y="100584"/>
            <a:ext cx="8605356" cy="5505495"/>
            <a:chOff x="1428624" y="676252"/>
            <a:chExt cx="8605356" cy="5505495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2BDFCBDF-E717-4295-A2DA-B6EB1382ACAA}"/>
                </a:ext>
              </a:extLst>
            </p:cNvPr>
            <p:cNvGrpSpPr/>
            <p:nvPr/>
          </p:nvGrpSpPr>
          <p:grpSpPr>
            <a:xfrm>
              <a:off x="1428624" y="676252"/>
              <a:ext cx="8605356" cy="5505495"/>
              <a:chOff x="1428624" y="676252"/>
              <a:chExt cx="8605356" cy="5505495"/>
            </a:xfrm>
          </p:grpSpPr>
          <p:pic>
            <p:nvPicPr>
              <p:cNvPr id="5" name="Picture 4" descr="A close up of a device&#10;&#10;Description generated with high confidence">
                <a:extLst>
                  <a:ext uri="{FF2B5EF4-FFF2-40B4-BE49-F238E27FC236}">
                    <a16:creationId xmlns:a16="http://schemas.microsoft.com/office/drawing/2014/main" id="{CB3E80E5-781B-4DA9-BD69-F78AF14FD6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038" t="4134" r="21141" b="3333"/>
              <a:stretch/>
            </p:blipFill>
            <p:spPr>
              <a:xfrm>
                <a:off x="3886200" y="676252"/>
                <a:ext cx="4133088" cy="5505495"/>
              </a:xfrm>
              <a:prstGeom prst="rect">
                <a:avLst/>
              </a:prstGeom>
            </p:spPr>
          </p:pic>
          <p:pic>
            <p:nvPicPr>
              <p:cNvPr id="7" name="Picture 6" descr="A close up of a logo&#10;&#10;Description generated with high confidence">
                <a:extLst>
                  <a:ext uri="{FF2B5EF4-FFF2-40B4-BE49-F238E27FC236}">
                    <a16:creationId xmlns:a16="http://schemas.microsoft.com/office/drawing/2014/main" id="{4835AF90-8A7A-40C7-AC8C-A76BEC24B3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796" t="13056" r="31379" b="15453"/>
              <a:stretch/>
            </p:blipFill>
            <p:spPr>
              <a:xfrm>
                <a:off x="1428624" y="718221"/>
                <a:ext cx="2434700" cy="2333956"/>
              </a:xfrm>
              <a:prstGeom prst="ellipse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pic>
            <p:nvPicPr>
              <p:cNvPr id="9" name="Picture 8" descr="A close up of a toy&#10;&#10;Description generated with high confidence">
                <a:extLst>
                  <a:ext uri="{FF2B5EF4-FFF2-40B4-BE49-F238E27FC236}">
                    <a16:creationId xmlns:a16="http://schemas.microsoft.com/office/drawing/2014/main" id="{6FC2CEAE-06D1-40A2-9485-9F0A886D6D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508" t="22361" r="20984" b="20133"/>
              <a:stretch/>
            </p:blipFill>
            <p:spPr>
              <a:xfrm>
                <a:off x="7741831" y="2682803"/>
                <a:ext cx="2292149" cy="2215423"/>
              </a:xfrm>
              <a:prstGeom prst="ellipse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AA849FD6-5DBF-47A2-A546-E15CD23524AA}"/>
                  </a:ext>
                </a:extLst>
              </p:cNvPr>
              <p:cNvSpPr/>
              <p:nvPr/>
            </p:nvSpPr>
            <p:spPr>
              <a:xfrm>
                <a:off x="5934780" y="2747434"/>
                <a:ext cx="787144" cy="800816"/>
              </a:xfrm>
              <a:prstGeom prst="ellipse">
                <a:avLst/>
              </a:prstGeom>
              <a:noFill/>
              <a:ln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id="{51E17150-FB83-4199-88E0-CBBF4A612CE6}"/>
                  </a:ext>
                </a:extLst>
              </p:cNvPr>
              <p:cNvSpPr/>
              <p:nvPr/>
            </p:nvSpPr>
            <p:spPr>
              <a:xfrm>
                <a:off x="7741831" y="2661308"/>
                <a:ext cx="2292149" cy="2292830"/>
              </a:xfrm>
              <a:prstGeom prst="ellipse">
                <a:avLst/>
              </a:prstGeom>
              <a:noFill/>
              <a:ln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EC1C2B36-7025-45E3-B528-3A1500E397B1}"/>
                  </a:ext>
                </a:extLst>
              </p:cNvPr>
              <p:cNvCxnSpPr>
                <a:cxnSpLocks/>
                <a:stCxn id="11" idx="0"/>
              </p:cNvCxnSpPr>
              <p:nvPr/>
            </p:nvCxnSpPr>
            <p:spPr>
              <a:xfrm flipH="1">
                <a:off x="6469294" y="2661308"/>
                <a:ext cx="2418612" cy="8612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6CDC18B7-28A2-4B60-B9A3-3D538115CCFC}"/>
                  </a:ext>
                </a:extLst>
              </p:cNvPr>
              <p:cNvCxnSpPr>
                <a:cxnSpLocks/>
                <a:stCxn id="11" idx="3"/>
              </p:cNvCxnSpPr>
              <p:nvPr/>
            </p:nvCxnSpPr>
            <p:spPr>
              <a:xfrm flipH="1" flipV="1">
                <a:off x="6328352" y="3548250"/>
                <a:ext cx="1749156" cy="107011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Oval 13">
                <a:extLst>
                  <a:ext uri="{FF2B5EF4-FFF2-40B4-BE49-F238E27FC236}">
                    <a16:creationId xmlns:a16="http://schemas.microsoft.com/office/drawing/2014/main" id="{F0C214B6-953E-4516-AFCF-41EC305A051C}"/>
                  </a:ext>
                </a:extLst>
              </p:cNvPr>
              <p:cNvSpPr/>
              <p:nvPr/>
            </p:nvSpPr>
            <p:spPr>
              <a:xfrm rot="339114">
                <a:off x="4410595" y="2335307"/>
                <a:ext cx="990283" cy="1033987"/>
              </a:xfrm>
              <a:prstGeom prst="ellipse">
                <a:avLst/>
              </a:prstGeom>
              <a:noFill/>
              <a:ln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977765B7-7FBA-45C8-8733-98D5B0252DAD}"/>
                  </a:ext>
                </a:extLst>
              </p:cNvPr>
              <p:cNvSpPr/>
              <p:nvPr/>
            </p:nvSpPr>
            <p:spPr>
              <a:xfrm rot="339114">
                <a:off x="1486719" y="717861"/>
                <a:ext cx="2292149" cy="2292830"/>
              </a:xfrm>
              <a:prstGeom prst="ellipse">
                <a:avLst/>
              </a:prstGeom>
              <a:noFill/>
              <a:ln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44627A02-2CAF-4412-BCEA-A7EACC0798B4}"/>
                  </a:ext>
                </a:extLst>
              </p:cNvPr>
              <p:cNvCxnSpPr>
                <a:cxnSpLocks/>
                <a:stCxn id="14" idx="0"/>
                <a:endCxn id="15" idx="7"/>
              </p:cNvCxnSpPr>
              <p:nvPr/>
            </p:nvCxnSpPr>
            <p:spPr>
              <a:xfrm flipH="1" flipV="1">
                <a:off x="3519086" y="1137390"/>
                <a:ext cx="1437567" cy="120043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C4033B4E-E6DA-4BFF-BDCF-C4DCE2A68B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6008" y="2996836"/>
                <a:ext cx="2143395" cy="28571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EE9CCB8-60F0-49CC-B20B-2046BE58C531}"/>
                </a:ext>
              </a:extLst>
            </p:cNvPr>
            <p:cNvSpPr txBox="1"/>
            <p:nvPr/>
          </p:nvSpPr>
          <p:spPr>
            <a:xfrm>
              <a:off x="2112588" y="3095574"/>
              <a:ext cx="133502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57Y</a:t>
              </a:r>
            </a:p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MS: 3.51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CAE0E4A-1BB0-4AA2-9BBD-C9B4CAFE5A11}"/>
                </a:ext>
              </a:extLst>
            </p:cNvPr>
            <p:cNvSpPr txBox="1"/>
            <p:nvPr/>
          </p:nvSpPr>
          <p:spPr>
            <a:xfrm>
              <a:off x="8556060" y="4995728"/>
              <a:ext cx="133502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35T</a:t>
              </a:r>
            </a:p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MS: 1.96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EBE9D911-3957-49A7-9E37-F2B2CBBEEA2C}"/>
                </a:ext>
              </a:extLst>
            </p:cNvPr>
            <p:cNvSpPr/>
            <p:nvPr/>
          </p:nvSpPr>
          <p:spPr>
            <a:xfrm>
              <a:off x="2221992" y="4206240"/>
              <a:ext cx="538251" cy="73152"/>
            </a:xfrm>
            <a:prstGeom prst="rect">
              <a:avLst/>
            </a:prstGeom>
            <a:solidFill>
              <a:srgbClr val="40E32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0B4A87FB-01DA-48CC-B771-9DA7A2323916}"/>
                </a:ext>
              </a:extLst>
            </p:cNvPr>
            <p:cNvSpPr/>
            <p:nvPr/>
          </p:nvSpPr>
          <p:spPr>
            <a:xfrm>
              <a:off x="2231135" y="4509763"/>
              <a:ext cx="538251" cy="73152"/>
            </a:xfrm>
            <a:prstGeom prst="rect">
              <a:avLst/>
            </a:prstGeom>
            <a:solidFill>
              <a:srgbClr val="381AE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0AA57194-514E-42FA-B15F-29B82D53FFFF}"/>
                </a:ext>
              </a:extLst>
            </p:cNvPr>
            <p:cNvSpPr/>
            <p:nvPr/>
          </p:nvSpPr>
          <p:spPr>
            <a:xfrm>
              <a:off x="2211638" y="4794998"/>
              <a:ext cx="538251" cy="73152"/>
            </a:xfrm>
            <a:prstGeom prst="rect">
              <a:avLst/>
            </a:prstGeom>
            <a:solidFill>
              <a:srgbClr val="C0A64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439AF0F-D979-4C20-A4FC-77352CF51E5F}"/>
                </a:ext>
              </a:extLst>
            </p:cNvPr>
            <p:cNvSpPr txBox="1"/>
            <p:nvPr/>
          </p:nvSpPr>
          <p:spPr>
            <a:xfrm>
              <a:off x="2790813" y="4073389"/>
              <a:ext cx="7282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CD4BA45-84A3-484D-AEF0-F7458C678279}"/>
                </a:ext>
              </a:extLst>
            </p:cNvPr>
            <p:cNvSpPr txBox="1"/>
            <p:nvPr/>
          </p:nvSpPr>
          <p:spPr>
            <a:xfrm>
              <a:off x="2803761" y="4381166"/>
              <a:ext cx="950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57Y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1881342-22BD-4B7F-96C6-A214BAC2E0A4}"/>
                </a:ext>
              </a:extLst>
            </p:cNvPr>
            <p:cNvSpPr txBox="1"/>
            <p:nvPr/>
          </p:nvSpPr>
          <p:spPr>
            <a:xfrm>
              <a:off x="2803761" y="4646361"/>
              <a:ext cx="950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35T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C610F285-CE98-4A20-94C9-90763C3310D0}"/>
              </a:ext>
            </a:extLst>
          </p:cNvPr>
          <p:cNvSpPr txBox="1"/>
          <p:nvPr/>
        </p:nvSpPr>
        <p:spPr>
          <a:xfrm>
            <a:off x="738644" y="5792254"/>
            <a:ext cx="11157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position of the STN1 and two mutants structures obtained at 100 ns of simulation run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35309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E686C94A-9E06-4273-BF5C-7168183E6A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20" t="13472" r="8949" b="36855"/>
          <a:stretch/>
        </p:blipFill>
        <p:spPr>
          <a:xfrm>
            <a:off x="0" y="0"/>
            <a:ext cx="5310098" cy="3406536"/>
          </a:xfrm>
          <a:prstGeom prst="rect">
            <a:avLst/>
          </a:prstGeom>
        </p:spPr>
      </p:pic>
      <p:pic>
        <p:nvPicPr>
          <p:cNvPr id="3" name="Picture 2" descr="A close up of a map&#10;&#10;Description generated with very high confidence">
            <a:extLst>
              <a:ext uri="{FF2B5EF4-FFF2-40B4-BE49-F238E27FC236}">
                <a16:creationId xmlns:a16="http://schemas.microsoft.com/office/drawing/2014/main" id="{D5E11922-0EEA-45AC-A06E-9285DE55ACC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03" t="13472" r="9165" b="36855"/>
          <a:stretch/>
        </p:blipFill>
        <p:spPr>
          <a:xfrm>
            <a:off x="5310098" y="44928"/>
            <a:ext cx="5310098" cy="3406537"/>
          </a:xfrm>
          <a:prstGeom prst="rect">
            <a:avLst/>
          </a:prstGeom>
        </p:spPr>
      </p:pic>
      <p:pic>
        <p:nvPicPr>
          <p:cNvPr id="4" name="Picture 3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048B8378-3868-4731-B506-5456DD199EC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6" t="13459" r="40168" b="41635"/>
          <a:stretch/>
        </p:blipFill>
        <p:spPr>
          <a:xfrm>
            <a:off x="0" y="3541142"/>
            <a:ext cx="5358874" cy="33166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7E0018A-7737-4476-9AE4-20A30ADC2611}"/>
              </a:ext>
            </a:extLst>
          </p:cNvPr>
          <p:cNvSpPr txBox="1"/>
          <p:nvPr/>
        </p:nvSpPr>
        <p:spPr>
          <a:xfrm>
            <a:off x="3791849" y="44928"/>
            <a:ext cx="1354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/>
              <a:t>D157Y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B2ACC40-542D-4877-8291-3D401397F263}"/>
              </a:ext>
            </a:extLst>
          </p:cNvPr>
          <p:cNvCxnSpPr>
            <a:cxnSpLocks/>
          </p:cNvCxnSpPr>
          <p:nvPr/>
        </p:nvCxnSpPr>
        <p:spPr>
          <a:xfrm>
            <a:off x="3395034" y="238220"/>
            <a:ext cx="39681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FA32F65-5D7B-4336-918B-2F2CA09121DC}"/>
              </a:ext>
            </a:extLst>
          </p:cNvPr>
          <p:cNvCxnSpPr>
            <a:cxnSpLocks/>
          </p:cNvCxnSpPr>
          <p:nvPr/>
        </p:nvCxnSpPr>
        <p:spPr>
          <a:xfrm>
            <a:off x="3395034" y="442382"/>
            <a:ext cx="396815" cy="0"/>
          </a:xfrm>
          <a:prstGeom prst="line">
            <a:avLst/>
          </a:prstGeom>
          <a:ln w="28575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5E7694C-19DC-4C95-9A9A-5B4012AC449E}"/>
              </a:ext>
            </a:extLst>
          </p:cNvPr>
          <p:cNvSpPr txBox="1"/>
          <p:nvPr/>
        </p:nvSpPr>
        <p:spPr>
          <a:xfrm>
            <a:off x="3791849" y="266445"/>
            <a:ext cx="1354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/>
              <a:t>D157Y_Run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20E25CF-CED4-43B9-B07E-6F858FAC4FB1}"/>
              </a:ext>
            </a:extLst>
          </p:cNvPr>
          <p:cNvSpPr txBox="1"/>
          <p:nvPr/>
        </p:nvSpPr>
        <p:spPr>
          <a:xfrm>
            <a:off x="9214091" y="139814"/>
            <a:ext cx="1354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/>
              <a:t>D157Y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7C7125D-CC67-46CD-B424-3A2F64701521}"/>
              </a:ext>
            </a:extLst>
          </p:cNvPr>
          <p:cNvCxnSpPr>
            <a:cxnSpLocks/>
          </p:cNvCxnSpPr>
          <p:nvPr/>
        </p:nvCxnSpPr>
        <p:spPr>
          <a:xfrm>
            <a:off x="8817276" y="333106"/>
            <a:ext cx="39681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0383514-88EC-46C7-8560-9B51FD1FDE05}"/>
              </a:ext>
            </a:extLst>
          </p:cNvPr>
          <p:cNvCxnSpPr>
            <a:cxnSpLocks/>
          </p:cNvCxnSpPr>
          <p:nvPr/>
        </p:nvCxnSpPr>
        <p:spPr>
          <a:xfrm>
            <a:off x="8817276" y="528642"/>
            <a:ext cx="396815" cy="0"/>
          </a:xfrm>
          <a:prstGeom prst="line">
            <a:avLst/>
          </a:prstGeom>
          <a:ln w="28575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16F9A50-4AE6-4DC6-8C18-8E5AD4214E84}"/>
              </a:ext>
            </a:extLst>
          </p:cNvPr>
          <p:cNvSpPr txBox="1"/>
          <p:nvPr/>
        </p:nvSpPr>
        <p:spPr>
          <a:xfrm>
            <a:off x="9214091" y="352705"/>
            <a:ext cx="1354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/>
              <a:t>D157Y_ Run 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77C30F2-36B4-4BA5-943A-BB72B4511100}"/>
              </a:ext>
            </a:extLst>
          </p:cNvPr>
          <p:cNvSpPr txBox="1"/>
          <p:nvPr/>
        </p:nvSpPr>
        <p:spPr>
          <a:xfrm>
            <a:off x="3911541" y="3681192"/>
            <a:ext cx="1354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/>
              <a:t>D157Y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1C43EE4-B451-4FD3-B63B-B6449C36B95C}"/>
              </a:ext>
            </a:extLst>
          </p:cNvPr>
          <p:cNvCxnSpPr>
            <a:cxnSpLocks/>
          </p:cNvCxnSpPr>
          <p:nvPr/>
        </p:nvCxnSpPr>
        <p:spPr>
          <a:xfrm>
            <a:off x="3514726" y="3874484"/>
            <a:ext cx="39681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019BD48-839B-4750-802B-D7B61B88EAFF}"/>
              </a:ext>
            </a:extLst>
          </p:cNvPr>
          <p:cNvCxnSpPr>
            <a:cxnSpLocks/>
          </p:cNvCxnSpPr>
          <p:nvPr/>
        </p:nvCxnSpPr>
        <p:spPr>
          <a:xfrm>
            <a:off x="3514726" y="4070020"/>
            <a:ext cx="396815" cy="0"/>
          </a:xfrm>
          <a:prstGeom prst="line">
            <a:avLst/>
          </a:prstGeom>
          <a:ln w="28575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8401C331-1C94-40A5-82A7-2B98263C6DFC}"/>
              </a:ext>
            </a:extLst>
          </p:cNvPr>
          <p:cNvSpPr txBox="1"/>
          <p:nvPr/>
        </p:nvSpPr>
        <p:spPr>
          <a:xfrm>
            <a:off x="3911541" y="3894083"/>
            <a:ext cx="13543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/>
              <a:t>D157Y_ Run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86CDBD-DA63-4B05-9A7F-F2DC813BEFBB}"/>
              </a:ext>
            </a:extLst>
          </p:cNvPr>
          <p:cNvSpPr txBox="1"/>
          <p:nvPr/>
        </p:nvSpPr>
        <p:spPr>
          <a:xfrm>
            <a:off x="794172" y="83472"/>
            <a:ext cx="5089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4B5D78D-C8FE-4B44-AC4C-F4135F92B72B}"/>
              </a:ext>
            </a:extLst>
          </p:cNvPr>
          <p:cNvSpPr txBox="1"/>
          <p:nvPr/>
        </p:nvSpPr>
        <p:spPr>
          <a:xfrm>
            <a:off x="6087915" y="109036"/>
            <a:ext cx="5089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2D42E72-F79A-469A-93E3-E5F729A3D98A}"/>
              </a:ext>
            </a:extLst>
          </p:cNvPr>
          <p:cNvSpPr txBox="1"/>
          <p:nvPr/>
        </p:nvSpPr>
        <p:spPr>
          <a:xfrm>
            <a:off x="886187" y="3650414"/>
            <a:ext cx="5089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B38F15-7745-4C97-93DA-A5A083FD9578}"/>
              </a:ext>
            </a:extLst>
          </p:cNvPr>
          <p:cNvSpPr txBox="1"/>
          <p:nvPr/>
        </p:nvSpPr>
        <p:spPr>
          <a:xfrm>
            <a:off x="5720134" y="6135963"/>
            <a:ext cx="6194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 simulation of D157Y run in duplicate at 300 K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33945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05FE6A12-77D6-4B78-8B43-D6FD44AFC7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89" t="13750" r="9241" b="36478"/>
          <a:stretch/>
        </p:blipFill>
        <p:spPr>
          <a:xfrm>
            <a:off x="901450" y="117710"/>
            <a:ext cx="4870107" cy="3123349"/>
          </a:xfrm>
          <a:prstGeom prst="rect">
            <a:avLst/>
          </a:prstGeom>
        </p:spPr>
      </p:pic>
      <p:pic>
        <p:nvPicPr>
          <p:cNvPr id="3" name="Picture 2" descr="A close up of a logo&#10;&#10;Description generated with very high confidence">
            <a:extLst>
              <a:ext uri="{FF2B5EF4-FFF2-40B4-BE49-F238E27FC236}">
                <a16:creationId xmlns:a16="http://schemas.microsoft.com/office/drawing/2014/main" id="{7E083C03-AB18-4907-A0AE-7138D388978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4" t="14088" r="40151" b="41761"/>
          <a:stretch/>
        </p:blipFill>
        <p:spPr>
          <a:xfrm>
            <a:off x="5964926" y="96570"/>
            <a:ext cx="5088751" cy="3117193"/>
          </a:xfrm>
          <a:prstGeom prst="rect">
            <a:avLst/>
          </a:prstGeom>
        </p:spPr>
      </p:pic>
      <p:pic>
        <p:nvPicPr>
          <p:cNvPr id="4" name="Picture 3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1F21833C-106E-4F77-8BCB-BF4E4616AC8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9" t="13473" r="41282" b="48718"/>
          <a:stretch/>
        </p:blipFill>
        <p:spPr>
          <a:xfrm>
            <a:off x="3601872" y="3421892"/>
            <a:ext cx="4919652" cy="2604416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6B50C2C1-66FC-414B-9B92-E75BF6FF215B}"/>
              </a:ext>
            </a:extLst>
          </p:cNvPr>
          <p:cNvGrpSpPr/>
          <p:nvPr/>
        </p:nvGrpSpPr>
        <p:grpSpPr>
          <a:xfrm>
            <a:off x="8839200" y="3718186"/>
            <a:ext cx="2309856" cy="758564"/>
            <a:chOff x="6096000" y="3516882"/>
            <a:chExt cx="2461403" cy="708209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0A11B30-FC89-4F71-A936-0EF6106F3C32}"/>
                </a:ext>
              </a:extLst>
            </p:cNvPr>
            <p:cNvSpPr/>
            <p:nvPr/>
          </p:nvSpPr>
          <p:spPr>
            <a:xfrm>
              <a:off x="6096001" y="3664260"/>
              <a:ext cx="559293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3758336-14BE-4CC5-8C11-8929D35C1D90}"/>
                </a:ext>
              </a:extLst>
            </p:cNvPr>
            <p:cNvSpPr txBox="1"/>
            <p:nvPr/>
          </p:nvSpPr>
          <p:spPr>
            <a:xfrm>
              <a:off x="6655294" y="3516882"/>
              <a:ext cx="1449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78 STN1WT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2340BB7-3A25-4EF9-B576-973F2B6F2D1A}"/>
                </a:ext>
              </a:extLst>
            </p:cNvPr>
            <p:cNvSpPr txBox="1"/>
            <p:nvPr/>
          </p:nvSpPr>
          <p:spPr>
            <a:xfrm>
              <a:off x="6655292" y="3715082"/>
              <a:ext cx="19021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78 STN1 D157Y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448A039-0CE5-45AC-B315-F6201D30B23B}"/>
                </a:ext>
              </a:extLst>
            </p:cNvPr>
            <p:cNvSpPr txBox="1"/>
            <p:nvPr/>
          </p:nvSpPr>
          <p:spPr>
            <a:xfrm>
              <a:off x="6655292" y="3855759"/>
              <a:ext cx="1824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  <a:spcBef>
                  <a:spcPts val="500"/>
                </a:spcBef>
                <a:spcAft>
                  <a:spcPts val="500"/>
                </a:spcAft>
              </a:pP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78 STN1 R135T</a:t>
              </a:r>
              <a:endPara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3704B79-AC93-472F-9396-1473F8CD5A27}"/>
                </a:ext>
              </a:extLst>
            </p:cNvPr>
            <p:cNvSpPr/>
            <p:nvPr/>
          </p:nvSpPr>
          <p:spPr>
            <a:xfrm>
              <a:off x="6096000" y="3848479"/>
              <a:ext cx="559293" cy="4571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1D66634B-9ED5-456D-957F-0CD3CC6CD0C9}"/>
                </a:ext>
              </a:extLst>
            </p:cNvPr>
            <p:cNvSpPr/>
            <p:nvPr/>
          </p:nvSpPr>
          <p:spPr>
            <a:xfrm>
              <a:off x="6099790" y="4032698"/>
              <a:ext cx="559293" cy="45719"/>
            </a:xfrm>
            <a:prstGeom prst="rect">
              <a:avLst/>
            </a:prstGeom>
            <a:solidFill>
              <a:srgbClr val="00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43E97BB2-72E9-4C0C-A292-598023968C96}"/>
              </a:ext>
            </a:extLst>
          </p:cNvPr>
          <p:cNvSpPr txBox="1"/>
          <p:nvPr/>
        </p:nvSpPr>
        <p:spPr>
          <a:xfrm>
            <a:off x="666750" y="6134100"/>
            <a:ext cx="11049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ure S4: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Conformational change analysis of D78.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RMSD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SASA, and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g during the entire simulation runs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1D23F8-C34D-406F-ABFA-6BEF3C85AA60}"/>
              </a:ext>
            </a:extLst>
          </p:cNvPr>
          <p:cNvSpPr txBox="1"/>
          <p:nvPr/>
        </p:nvSpPr>
        <p:spPr>
          <a:xfrm>
            <a:off x="381000" y="361950"/>
            <a:ext cx="4762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F12611-DB40-4105-9311-12838D305663}"/>
              </a:ext>
            </a:extLst>
          </p:cNvPr>
          <p:cNvSpPr txBox="1"/>
          <p:nvPr/>
        </p:nvSpPr>
        <p:spPr>
          <a:xfrm>
            <a:off x="5886450" y="228600"/>
            <a:ext cx="4762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90A792A-CC0B-48A4-B722-1DF0345D7760}"/>
              </a:ext>
            </a:extLst>
          </p:cNvPr>
          <p:cNvSpPr txBox="1"/>
          <p:nvPr/>
        </p:nvSpPr>
        <p:spPr>
          <a:xfrm>
            <a:off x="3181350" y="3505200"/>
            <a:ext cx="4762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44503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</TotalTime>
  <Words>126</Words>
  <Application>Microsoft Office PowerPoint</Application>
  <PresentationFormat>Widescreen</PresentationFormat>
  <Paragraphs>3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H</dc:creator>
  <cp:lastModifiedBy>MIH</cp:lastModifiedBy>
  <cp:revision>21</cp:revision>
  <dcterms:created xsi:type="dcterms:W3CDTF">2019-05-12T05:26:02Z</dcterms:created>
  <dcterms:modified xsi:type="dcterms:W3CDTF">2019-05-12T09:15:33Z</dcterms:modified>
</cp:coreProperties>
</file>